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3048" y="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8488B-D144-4576-BDFE-34A3A768F9D3}" type="datetimeFigureOut">
              <a:rPr lang="en-GB" smtClean="0"/>
              <a:t>04/08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F276A-1C42-456F-B487-D92008E74C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96400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8488B-D144-4576-BDFE-34A3A768F9D3}" type="datetimeFigureOut">
              <a:rPr lang="en-GB" smtClean="0"/>
              <a:t>04/08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F276A-1C42-456F-B487-D92008E74C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73997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8488B-D144-4576-BDFE-34A3A768F9D3}" type="datetimeFigureOut">
              <a:rPr lang="en-GB" smtClean="0"/>
              <a:t>04/08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F276A-1C42-456F-B487-D92008E74C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3830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8488B-D144-4576-BDFE-34A3A768F9D3}" type="datetimeFigureOut">
              <a:rPr lang="en-GB" smtClean="0"/>
              <a:t>04/08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F276A-1C42-456F-B487-D92008E74C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12621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8488B-D144-4576-BDFE-34A3A768F9D3}" type="datetimeFigureOut">
              <a:rPr lang="en-GB" smtClean="0"/>
              <a:t>04/08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F276A-1C42-456F-B487-D92008E74C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35143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8488B-D144-4576-BDFE-34A3A768F9D3}" type="datetimeFigureOut">
              <a:rPr lang="en-GB" smtClean="0"/>
              <a:t>04/08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F276A-1C42-456F-B487-D92008E74C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12346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8488B-D144-4576-BDFE-34A3A768F9D3}" type="datetimeFigureOut">
              <a:rPr lang="en-GB" smtClean="0"/>
              <a:t>04/08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F276A-1C42-456F-B487-D92008E74C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963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8488B-D144-4576-BDFE-34A3A768F9D3}" type="datetimeFigureOut">
              <a:rPr lang="en-GB" smtClean="0"/>
              <a:t>04/08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F276A-1C42-456F-B487-D92008E74C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23409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8488B-D144-4576-BDFE-34A3A768F9D3}" type="datetimeFigureOut">
              <a:rPr lang="en-GB" smtClean="0"/>
              <a:t>04/08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F276A-1C42-456F-B487-D92008E74C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55432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8488B-D144-4576-BDFE-34A3A768F9D3}" type="datetimeFigureOut">
              <a:rPr lang="en-GB" smtClean="0"/>
              <a:t>04/08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F276A-1C42-456F-B487-D92008E74C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73791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8488B-D144-4576-BDFE-34A3A768F9D3}" type="datetimeFigureOut">
              <a:rPr lang="en-GB" smtClean="0"/>
              <a:t>04/08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F276A-1C42-456F-B487-D92008E74C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70754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D8488B-D144-4576-BDFE-34A3A768F9D3}" type="datetimeFigureOut">
              <a:rPr lang="en-GB" smtClean="0"/>
              <a:t>04/08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FF276A-1C42-456F-B487-D92008E74C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8269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Tab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70346955"/>
              </p:ext>
            </p:extLst>
          </p:nvPr>
        </p:nvGraphicFramePr>
        <p:xfrm>
          <a:off x="620688" y="1115616"/>
          <a:ext cx="5472608" cy="3619500"/>
        </p:xfrm>
        <a:graphic>
          <a:graphicData uri="http://schemas.openxmlformats.org/drawingml/2006/table">
            <a:tbl>
              <a:tblPr/>
              <a:tblGrid>
                <a:gridCol w="919064"/>
                <a:gridCol w="2339435"/>
                <a:gridCol w="2214109"/>
              </a:tblGrid>
              <a:tr h="1905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DNA</a:t>
                      </a:r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plfication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 5'-3'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 5'-3'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7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ATCTTGTCTAAGGGTTC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TTCTGACACTCAAAGCCCAT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OS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ACATCAATTCCATGCTCCTA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ACTAAGGAGCATCAGG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74-ROS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ATCTTGTCTAAGGGTTC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ACTAAGGAGCATCAGG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OS1-CD7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ACATCAATTCCATGCTCCTA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TTCTGACACTCAAAGCCCAT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R-ABL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GTGAAACTCCAGACTGTC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CCTGACCTCCTGATTCG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L1-BCR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TCAGCTGGTTTCAGTAG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GTGGACGATGACATTC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GTGAAACTCCAGACTGTC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GTGGACGATGACATTC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L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TCAGCTGGTTTCAGTAG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CCTGACCTCCTGATTCG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NA amplfic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 5'-3'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 5'-3'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74-ROS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GCCTGTGAGCAAGATG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TTTCTCCACTTCCAACTCC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GGTACATTCCGCTCAC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ATCCTCTTCAAGCTGAAC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L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CTTGCAAGTGTCAACC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CACCCTCCCTTCGTATCTC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4296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63</TotalTime>
  <Words>57</Words>
  <Application>Microsoft Office PowerPoint</Application>
  <PresentationFormat>On-screen Show (4:3)</PresentationFormat>
  <Paragraphs>4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rgey Lekomtsev</dc:creator>
  <cp:lastModifiedBy>Sergey Lekomtsev</cp:lastModifiedBy>
  <cp:revision>107</cp:revision>
  <cp:lastPrinted>2016-05-24T10:48:23Z</cp:lastPrinted>
  <dcterms:created xsi:type="dcterms:W3CDTF">2015-08-13T12:18:06Z</dcterms:created>
  <dcterms:modified xsi:type="dcterms:W3CDTF">2016-08-04T13:02:39Z</dcterms:modified>
</cp:coreProperties>
</file>